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7"/>
    <p:restoredTop sz="94665"/>
  </p:normalViewPr>
  <p:slideViewPr>
    <p:cSldViewPr snapToGrid="0" snapToObjects="1" showGuides="1">
      <p:cViewPr varScale="1">
        <p:scale>
          <a:sx n="69" d="100"/>
          <a:sy n="69" d="100"/>
        </p:scale>
        <p:origin x="756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D26D0-FB51-D64C-A3F7-47ECE17BAA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433BB7-6089-634E-B7FB-8B7D11FD6D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9B17B-25C2-4E49-A7F6-FFCD08F55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174AFF-5C95-4A4A-9575-132B23CAE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5A7A09-3522-5148-821C-F422301DE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3939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5B9D8-ED5E-D54E-BE2B-D89314B27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F96DD5-FA2A-CA4A-B96C-86A21C77CA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160AA-3618-6F45-9F65-D174115F1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7872CA-5D1F-D14A-94AC-3B2896063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8330C5-D8D9-5844-B5B3-4C928893B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260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12E609-614A-D346-A4AE-2A99122593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0D96AC-2497-B246-8C66-B15D4FE55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FE47A7-FB26-8443-AA05-911D6D41B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8E2874-E98F-F94C-A063-5140D6BBF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74B05-D86A-2A4F-AE9E-842795E36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326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3ABF5-E051-FA43-A929-28CC5C98E4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1DA0A5-77EF-DC4A-B231-5000DB740D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6D564-6017-9447-B988-775FC398F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7C8F2D-D043-B140-84F5-613978F04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A0564-651F-A547-B3C9-ED4B50F9C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8140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98585-B7CC-6443-A84F-A05FE9AEE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A08148-0D4F-DE45-9E92-EEEB5510E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83245C-1735-2448-A423-4FE774B54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7A19D5-E095-564C-8D8E-07BF3F95A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EEEA86-1CB6-FA43-B328-DF5094B6CE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7609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EA9CBD-B84C-9841-A992-ECD27D4D9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C8839E-4CD8-BB48-BE8F-12C933EAB3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964226-3B0A-D34B-8BBA-CDE354339E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AC64FF-FCAC-7C4D-A496-50577147D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9CF17B-6008-DE46-87E6-8B6F71B0F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B69609-9F2F-A249-A510-9A8049FB4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399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E28FA-95EE-DA4B-984F-9B3041B8D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6026E3-75A1-A54B-94C3-628078C8B1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9D6AE8-ADE4-E845-8841-EA2DCE9545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771396-F077-3348-ABFE-7C9411F59A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ECA74A-814E-514B-B868-6D06037052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1D6C9F-61E8-E746-B386-4CF2522CE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0EEC9F-952D-AB4A-8EAC-571A81B17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0A7CDF-9376-CE4B-A177-2A36D2333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678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80233-7133-BD41-9E23-7C5992B74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40CCDE-3FA5-FA4B-A2AC-DC2AF0703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749028-63DA-244E-8F11-20753F8F3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912D78-AF84-F34D-A1B0-35D26BE05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6871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D746CD-C26D-4449-B8A8-0727389FC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D6BE6F-8441-B94E-9CE2-61BC83B99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7441F0-98CA-764D-98E4-FB819EDB9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771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6BA70-0CF6-DC46-9461-60A5E29B80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FE8761-FEA1-7F49-A68A-3BC567B941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4A9445-27A3-B946-8D1D-3EC79CA5CE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A33677-2DF4-8847-A268-7853B480C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445ACF-A8C2-D847-9F81-733475C67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F0CD27-EC23-AA4C-BCA8-53E581AA6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202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9B7A79-4AEB-6347-8181-3F70B6D9D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425B1B-DD27-AB4F-9C63-8C41A35FFC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0374DA-01D0-7043-A58A-911D128F53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C6DDD2-4556-5345-96D5-264B84FEF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19F65D-B747-5043-A0AA-0F192212B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8739E9-4E8D-7842-8BA0-E1DE4C7E5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712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799DB2-3849-EB42-B388-E3333F4E4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9290B1-5474-5B48-8E35-8AC2E1EC56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22B786-08EA-8744-B124-9F48FA0FA2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8A12D-13B3-C541-972D-7C91AB0BDDCB}" type="datetimeFigureOut">
              <a:rPr lang="en-GB" smtClean="0"/>
              <a:t>11/12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214446-D245-AB4B-AA87-402ED059C3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1B749-26C7-994C-94EE-E9C591DE3D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E0E3C-31D6-2147-B1C9-16CAF99F1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740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Relationship Id="rId9" Type="http://schemas.openxmlformats.org/officeDocument/2006/relationships/image" Target="../media/image16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12" Type="http://schemas.openxmlformats.org/officeDocument/2006/relationships/image" Target="../media/image27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11" Type="http://schemas.openxmlformats.org/officeDocument/2006/relationships/image" Target="../media/image26.jpeg"/><Relationship Id="rId5" Type="http://schemas.openxmlformats.org/officeDocument/2006/relationships/image" Target="../media/image20.jpeg"/><Relationship Id="rId10" Type="http://schemas.openxmlformats.org/officeDocument/2006/relationships/image" Target="../media/image25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12" Type="http://schemas.openxmlformats.org/officeDocument/2006/relationships/image" Target="../media/image38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jpeg"/><Relationship Id="rId11" Type="http://schemas.openxmlformats.org/officeDocument/2006/relationships/image" Target="../media/image37.jpeg"/><Relationship Id="rId5" Type="http://schemas.openxmlformats.org/officeDocument/2006/relationships/image" Target="../media/image31.jpeg"/><Relationship Id="rId10" Type="http://schemas.openxmlformats.org/officeDocument/2006/relationships/image" Target="../media/image36.jpeg"/><Relationship Id="rId4" Type="http://schemas.openxmlformats.org/officeDocument/2006/relationships/image" Target="../media/image30.jpeg"/><Relationship Id="rId9" Type="http://schemas.openxmlformats.org/officeDocument/2006/relationships/image" Target="../media/image3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7B2A3F4C-DD73-7145-A3BE-F515CD34E567}"/>
              </a:ext>
            </a:extLst>
          </p:cNvPr>
          <p:cNvGrpSpPr/>
          <p:nvPr/>
        </p:nvGrpSpPr>
        <p:grpSpPr>
          <a:xfrm>
            <a:off x="558350" y="544581"/>
            <a:ext cx="11452054" cy="6021519"/>
            <a:chOff x="558350" y="544581"/>
            <a:chExt cx="11452054" cy="6021519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BEDE6B86-8820-D841-A9B2-2C7EE4938372}"/>
                </a:ext>
              </a:extLst>
            </p:cNvPr>
            <p:cNvGrpSpPr/>
            <p:nvPr/>
          </p:nvGrpSpPr>
          <p:grpSpPr>
            <a:xfrm>
              <a:off x="713753" y="544581"/>
              <a:ext cx="11296651" cy="2884419"/>
              <a:chOff x="713753" y="544581"/>
              <a:chExt cx="11296651" cy="2884419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CEA140D8-CC62-8C4B-BF58-B5F9D65B93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0662" t="9911" r="23431" b="27198"/>
              <a:stretch/>
            </p:blipFill>
            <p:spPr>
              <a:xfrm>
                <a:off x="3451760" y="805892"/>
                <a:ext cx="2807502" cy="2365224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2258ECE-86DF-874C-BA14-7AF46B69A9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4079" t="19232" r="25640" b="7021"/>
              <a:stretch/>
            </p:blipFill>
            <p:spPr>
              <a:xfrm>
                <a:off x="6463418" y="601764"/>
                <a:ext cx="2524976" cy="2773480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E99AC848-C85D-484E-81C4-DA9E9DC9B4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0898" t="16165" r="22989" b="7138"/>
              <a:stretch/>
            </p:blipFill>
            <p:spPr>
              <a:xfrm>
                <a:off x="9192549" y="544581"/>
                <a:ext cx="2817855" cy="2884419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EEA95292-65E2-E647-9453-A89B6AB135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5493" t="12388" r="24049" b="11033"/>
              <a:stretch/>
            </p:blipFill>
            <p:spPr>
              <a:xfrm>
                <a:off x="713753" y="548514"/>
                <a:ext cx="2533851" cy="2879981"/>
              </a:xfrm>
              <a:prstGeom prst="rect">
                <a:avLst/>
              </a:prstGeom>
            </p:spPr>
          </p:pic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83F3B394-7780-5D4C-A843-1A6ADB3D6D46}"/>
                </a:ext>
              </a:extLst>
            </p:cNvPr>
            <p:cNvGrpSpPr/>
            <p:nvPr/>
          </p:nvGrpSpPr>
          <p:grpSpPr>
            <a:xfrm>
              <a:off x="558350" y="3552992"/>
              <a:ext cx="11369832" cy="3013108"/>
              <a:chOff x="906308" y="3439703"/>
              <a:chExt cx="11369832" cy="3013108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618986C1-5C48-F74F-AA71-ABC3F5131E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2753" t="15103" r="16892" b="15871"/>
              <a:stretch/>
            </p:blipFill>
            <p:spPr>
              <a:xfrm>
                <a:off x="4073514" y="3648269"/>
                <a:ext cx="3030858" cy="2595977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F5F5BB14-3CC2-EB4B-95D5-75A59633E1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34860" t="18761" r="28026" b="1121"/>
              <a:stretch/>
            </p:blipFill>
            <p:spPr>
              <a:xfrm>
                <a:off x="7333908" y="3439703"/>
                <a:ext cx="1863778" cy="3013108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F5D908CE-10A1-6944-9847-62CC8A55ED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3284" t="19705" r="18218" b="10207"/>
              <a:stretch/>
            </p:blipFill>
            <p:spPr>
              <a:xfrm>
                <a:off x="906308" y="3628300"/>
                <a:ext cx="2937670" cy="2635915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DB733FE0-4279-F349-897A-81504036BD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1517" t="10148" r="21752" b="13038"/>
              <a:stretch/>
            </p:blipFill>
            <p:spPr>
              <a:xfrm>
                <a:off x="9427221" y="3501829"/>
                <a:ext cx="2848919" cy="2888857"/>
              </a:xfrm>
              <a:prstGeom prst="rect">
                <a:avLst/>
              </a:prstGeom>
            </p:spPr>
          </p:pic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C1BDBAB6-488E-6346-96C2-43B139A6B011}"/>
              </a:ext>
            </a:extLst>
          </p:cNvPr>
          <p:cNvSpPr txBox="1"/>
          <p:nvPr/>
        </p:nvSpPr>
        <p:spPr>
          <a:xfrm>
            <a:off x="574535" y="250853"/>
            <a:ext cx="2605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ortic Sinus; Controls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634AC11E-EE1E-7444-87AD-02B7F9276687}"/>
              </a:ext>
            </a:extLst>
          </p:cNvPr>
          <p:cNvGrpSpPr/>
          <p:nvPr/>
        </p:nvGrpSpPr>
        <p:grpSpPr>
          <a:xfrm>
            <a:off x="3342010" y="3043483"/>
            <a:ext cx="841572" cy="385517"/>
            <a:chOff x="679731" y="3043483"/>
            <a:chExt cx="841572" cy="385517"/>
          </a:xfrm>
        </p:grpSpPr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42C7C3E-787F-484F-B181-658944DDE12F}"/>
                </a:ext>
              </a:extLst>
            </p:cNvPr>
            <p:cNvCxnSpPr>
              <a:cxnSpLocks/>
            </p:cNvCxnSpPr>
            <p:nvPr/>
          </p:nvCxnSpPr>
          <p:spPr>
            <a:xfrm>
              <a:off x="679731" y="3429000"/>
              <a:ext cx="841572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FFD54F4-F28F-BC4A-9E1C-82A0BFA6627F}"/>
                </a:ext>
              </a:extLst>
            </p:cNvPr>
            <p:cNvSpPr txBox="1"/>
            <p:nvPr/>
          </p:nvSpPr>
          <p:spPr>
            <a:xfrm>
              <a:off x="679731" y="3043483"/>
              <a:ext cx="8415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500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575747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C9CA37-7F33-E04A-B1AB-F534797BFFFD}"/>
              </a:ext>
            </a:extLst>
          </p:cNvPr>
          <p:cNvSpPr txBox="1"/>
          <p:nvPr/>
        </p:nvSpPr>
        <p:spPr>
          <a:xfrm>
            <a:off x="226578" y="105196"/>
            <a:ext cx="4062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ortic Sinus; </a:t>
            </a:r>
            <a:r>
              <a:rPr lang="en-NZ" dirty="0"/>
              <a:t>ribose-cysteine treated</a:t>
            </a:r>
            <a:endParaRPr lang="en-GB" dirty="0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85658C06-8E21-0440-8799-72DB2A580F26}"/>
              </a:ext>
            </a:extLst>
          </p:cNvPr>
          <p:cNvGrpSpPr/>
          <p:nvPr/>
        </p:nvGrpSpPr>
        <p:grpSpPr>
          <a:xfrm>
            <a:off x="398561" y="267784"/>
            <a:ext cx="11380746" cy="3899858"/>
            <a:chOff x="398561" y="267784"/>
            <a:chExt cx="11380746" cy="389985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5812FB6-FFA5-424A-87F6-E82440629F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9130" t="26194" r="21398" b="33806"/>
            <a:stretch/>
          </p:blipFill>
          <p:spPr>
            <a:xfrm>
              <a:off x="398561" y="1335169"/>
              <a:ext cx="3504145" cy="176508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14BA61A-97DB-E246-BFBA-CCC5263744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967" t="27611" r="27055" b="20000"/>
            <a:stretch/>
          </p:blipFill>
          <p:spPr>
            <a:xfrm>
              <a:off x="6255347" y="1061814"/>
              <a:ext cx="2650238" cy="2311799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B33736ED-27DC-A443-A341-F97FE61202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111" t="4838" r="28114" b="12802"/>
            <a:stretch/>
          </p:blipFill>
          <p:spPr>
            <a:xfrm>
              <a:off x="3730478" y="400556"/>
              <a:ext cx="2697097" cy="3634314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54E15BED-B85B-024D-8C5F-B973637A82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5758" t="10030" r="22548" b="1593"/>
            <a:stretch/>
          </p:blipFill>
          <p:spPr>
            <a:xfrm>
              <a:off x="8733358" y="267784"/>
              <a:ext cx="3045949" cy="3899858"/>
            </a:xfrm>
            <a:prstGeom prst="rect">
              <a:avLst/>
            </a:prstGeom>
          </p:spPr>
        </p:pic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9322010-8B3E-B04A-8A8F-25EADE5CA236}"/>
              </a:ext>
            </a:extLst>
          </p:cNvPr>
          <p:cNvGrpSpPr/>
          <p:nvPr/>
        </p:nvGrpSpPr>
        <p:grpSpPr>
          <a:xfrm>
            <a:off x="273946" y="3687089"/>
            <a:ext cx="11533060" cy="3170912"/>
            <a:chOff x="273946" y="3687089"/>
            <a:chExt cx="11533060" cy="3170912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F7C9A520-76AF-5749-BAC2-D8BB1AFB90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1517" t="17582" r="22105" b="19527"/>
            <a:stretch/>
          </p:blipFill>
          <p:spPr>
            <a:xfrm>
              <a:off x="273946" y="3884945"/>
              <a:ext cx="3321906" cy="2775199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8BC733E4-B22F-DD48-806B-3A380F6312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581" t="28200" r="24492" b="27552"/>
            <a:stretch/>
          </p:blipFill>
          <p:spPr>
            <a:xfrm rot="5400000">
              <a:off x="3292160" y="4296278"/>
              <a:ext cx="2941816" cy="1952532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8C4448B6-FEC5-4345-BF5D-180516E01C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7525" t="30679" r="18660" b="16224"/>
            <a:stretch/>
          </p:blipFill>
          <p:spPr>
            <a:xfrm rot="5400000">
              <a:off x="5516348" y="4101025"/>
              <a:ext cx="3170912" cy="2343039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D3121E17-60BD-FB4F-A277-5C0FC5F114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0986" t="26314" r="22282" b="24601"/>
            <a:stretch/>
          </p:blipFill>
          <p:spPr>
            <a:xfrm>
              <a:off x="8464272" y="4189540"/>
              <a:ext cx="3342734" cy="2166009"/>
            </a:xfrm>
            <a:prstGeom prst="rect">
              <a:avLst/>
            </a:prstGeom>
          </p:spPr>
        </p:pic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5447EDC4-A129-3248-8C13-5991F5F93719}"/>
              </a:ext>
            </a:extLst>
          </p:cNvPr>
          <p:cNvGrpSpPr/>
          <p:nvPr/>
        </p:nvGrpSpPr>
        <p:grpSpPr>
          <a:xfrm>
            <a:off x="2694648" y="3164864"/>
            <a:ext cx="987229" cy="369332"/>
            <a:chOff x="679731" y="3059668"/>
            <a:chExt cx="987229" cy="369332"/>
          </a:xfrm>
        </p:grpSpPr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C65A468C-3D05-B342-B086-D4F43F98E99B}"/>
                </a:ext>
              </a:extLst>
            </p:cNvPr>
            <p:cNvCxnSpPr/>
            <p:nvPr/>
          </p:nvCxnSpPr>
          <p:spPr>
            <a:xfrm>
              <a:off x="679731" y="3429000"/>
              <a:ext cx="987229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C554DDC-7060-A942-BB12-E68DA073D605}"/>
                </a:ext>
              </a:extLst>
            </p:cNvPr>
            <p:cNvSpPr txBox="1"/>
            <p:nvPr/>
          </p:nvSpPr>
          <p:spPr>
            <a:xfrm>
              <a:off x="752559" y="3059668"/>
              <a:ext cx="8415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500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22946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68">
            <a:extLst>
              <a:ext uri="{FF2B5EF4-FFF2-40B4-BE49-F238E27FC236}">
                <a16:creationId xmlns:a16="http://schemas.microsoft.com/office/drawing/2014/main" id="{9106F3D8-F862-504D-8ED3-1B8F5C90270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88219" y="7040069"/>
            <a:ext cx="2683469" cy="20096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77A8D7E-D987-D14F-9DCD-E8C099B22161}"/>
              </a:ext>
            </a:extLst>
          </p:cNvPr>
          <p:cNvSpPr txBox="1"/>
          <p:nvPr/>
        </p:nvSpPr>
        <p:spPr>
          <a:xfrm>
            <a:off x="226578" y="105196"/>
            <a:ext cx="46920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rachiocephalic branch; </a:t>
            </a:r>
            <a:r>
              <a:rPr lang="en-NZ" dirty="0"/>
              <a:t>Controls</a:t>
            </a:r>
            <a:endParaRPr lang="en-GB" dirty="0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F35FC292-63F9-E146-B923-88DFF8A75DE6}"/>
              </a:ext>
            </a:extLst>
          </p:cNvPr>
          <p:cNvGrpSpPr/>
          <p:nvPr/>
        </p:nvGrpSpPr>
        <p:grpSpPr>
          <a:xfrm>
            <a:off x="6216446" y="6216932"/>
            <a:ext cx="1131123" cy="369332"/>
            <a:chOff x="679731" y="3075852"/>
            <a:chExt cx="1131123" cy="369332"/>
          </a:xfrm>
        </p:grpSpPr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26323C6D-B7C8-0244-9F06-2EE1DD96B166}"/>
                </a:ext>
              </a:extLst>
            </p:cNvPr>
            <p:cNvCxnSpPr>
              <a:cxnSpLocks/>
            </p:cNvCxnSpPr>
            <p:nvPr/>
          </p:nvCxnSpPr>
          <p:spPr>
            <a:xfrm>
              <a:off x="679731" y="3429000"/>
              <a:ext cx="113112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98B6EA4-B25D-1141-A87D-409B9F268796}"/>
                </a:ext>
              </a:extLst>
            </p:cNvPr>
            <p:cNvSpPr txBox="1"/>
            <p:nvPr/>
          </p:nvSpPr>
          <p:spPr>
            <a:xfrm>
              <a:off x="809203" y="3075852"/>
              <a:ext cx="9196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250µm</a:t>
              </a:r>
            </a:p>
          </p:txBody>
        </p:sp>
      </p:grpSp>
      <p:pic>
        <p:nvPicPr>
          <p:cNvPr id="49" name="Picture 48">
            <a:extLst>
              <a:ext uri="{FF2B5EF4-FFF2-40B4-BE49-F238E27FC236}">
                <a16:creationId xmlns:a16="http://schemas.microsoft.com/office/drawing/2014/main" id="{06ACEB39-255A-B147-8D67-38B3760501A2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31809" y="4702671"/>
            <a:ext cx="2683469" cy="2009672"/>
          </a:xfrm>
          <a:prstGeom prst="rect">
            <a:avLst/>
          </a:prstGeom>
        </p:spPr>
      </p:pic>
      <p:grpSp>
        <p:nvGrpSpPr>
          <p:cNvPr id="71" name="Group 70">
            <a:extLst>
              <a:ext uri="{FF2B5EF4-FFF2-40B4-BE49-F238E27FC236}">
                <a16:creationId xmlns:a16="http://schemas.microsoft.com/office/drawing/2014/main" id="{A7CF41CD-399C-A345-A3F6-B07BB7848BA6}"/>
              </a:ext>
            </a:extLst>
          </p:cNvPr>
          <p:cNvGrpSpPr/>
          <p:nvPr/>
        </p:nvGrpSpPr>
        <p:grpSpPr>
          <a:xfrm>
            <a:off x="85162" y="2557082"/>
            <a:ext cx="12021676" cy="2009672"/>
            <a:chOff x="84008" y="2775567"/>
            <a:chExt cx="12021676" cy="2009672"/>
          </a:xfrm>
        </p:grpSpPr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737E7785-A290-F54B-8BDE-3411E4CA81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09480" y="2775567"/>
              <a:ext cx="2683469" cy="2009672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319A93C7-189B-EF44-A437-F6701C41ADF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422215" y="2775567"/>
              <a:ext cx="2683469" cy="2009672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AEC4A71D-F2A1-284D-AAD9-74F28FFA1A1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96744" y="2775567"/>
              <a:ext cx="2683469" cy="2009672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5514637C-7A8D-8640-B90D-F855C614AC6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4008" y="2775567"/>
              <a:ext cx="2683469" cy="2009672"/>
            </a:xfrm>
            <a:prstGeom prst="rect">
              <a:avLst/>
            </a:prstGeom>
          </p:spPr>
        </p:pic>
      </p:grpSp>
      <p:pic>
        <p:nvPicPr>
          <p:cNvPr id="63" name="Picture 62">
            <a:extLst>
              <a:ext uri="{FF2B5EF4-FFF2-40B4-BE49-F238E27FC236}">
                <a16:creationId xmlns:a16="http://schemas.microsoft.com/office/drawing/2014/main" id="{E56929BC-1FFE-4F4A-A3DE-1FA567B5779E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8398" y="4678395"/>
            <a:ext cx="2683469" cy="2009672"/>
          </a:xfrm>
          <a:prstGeom prst="rect">
            <a:avLst/>
          </a:prstGeom>
        </p:spPr>
      </p:pic>
      <p:grpSp>
        <p:nvGrpSpPr>
          <p:cNvPr id="70" name="Group 69">
            <a:extLst>
              <a:ext uri="{FF2B5EF4-FFF2-40B4-BE49-F238E27FC236}">
                <a16:creationId xmlns:a16="http://schemas.microsoft.com/office/drawing/2014/main" id="{71320A71-FB3F-F541-826B-5A8B78279F5D}"/>
              </a:ext>
            </a:extLst>
          </p:cNvPr>
          <p:cNvGrpSpPr/>
          <p:nvPr/>
        </p:nvGrpSpPr>
        <p:grpSpPr>
          <a:xfrm>
            <a:off x="81114" y="438992"/>
            <a:ext cx="12029771" cy="2074408"/>
            <a:chOff x="75916" y="673661"/>
            <a:chExt cx="12029771" cy="2074408"/>
          </a:xfrm>
        </p:grpSpPr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B21B900F-9B19-5C43-B6EE-BA4679CE9A7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91350" y="738397"/>
              <a:ext cx="2683469" cy="2009672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0581768A-895F-6240-A7A0-027F29091D1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422218" y="673661"/>
              <a:ext cx="2683469" cy="2009672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DABD5940-4DE1-304E-A26F-71A8690108C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06784" y="736373"/>
              <a:ext cx="2683469" cy="2009672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BD9AD623-CAA5-7048-B540-BA9E02C73B9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5916" y="712097"/>
              <a:ext cx="2683469" cy="200967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835197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8363075-FD01-4444-8B33-2EDD64F70100}"/>
              </a:ext>
            </a:extLst>
          </p:cNvPr>
          <p:cNvSpPr txBox="1"/>
          <p:nvPr/>
        </p:nvSpPr>
        <p:spPr>
          <a:xfrm>
            <a:off x="99804" y="153749"/>
            <a:ext cx="46920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rachiocephalic branch; </a:t>
            </a:r>
            <a:r>
              <a:rPr lang="en-NZ" dirty="0"/>
              <a:t>ribose-cysteine treated</a:t>
            </a:r>
            <a:endParaRPr lang="en-GB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8B2D3CDE-76C2-A048-BBEB-9FB0CE15F42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4241" y="4734021"/>
            <a:ext cx="2890126" cy="2030922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48395D39-EE89-734C-8963-524DAD4AD2C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2171" y="4758117"/>
            <a:ext cx="2890126" cy="2043239"/>
          </a:xfrm>
          <a:prstGeom prst="rect">
            <a:avLst/>
          </a:prstGeom>
        </p:spPr>
      </p:pic>
      <p:grpSp>
        <p:nvGrpSpPr>
          <p:cNvPr id="55" name="Group 54">
            <a:extLst>
              <a:ext uri="{FF2B5EF4-FFF2-40B4-BE49-F238E27FC236}">
                <a16:creationId xmlns:a16="http://schemas.microsoft.com/office/drawing/2014/main" id="{ED7A193A-B90C-164A-A0E9-1CD057C8BC2C}"/>
              </a:ext>
            </a:extLst>
          </p:cNvPr>
          <p:cNvGrpSpPr/>
          <p:nvPr/>
        </p:nvGrpSpPr>
        <p:grpSpPr>
          <a:xfrm>
            <a:off x="110653" y="2937591"/>
            <a:ext cx="11970693" cy="1755973"/>
            <a:chOff x="155301" y="3245088"/>
            <a:chExt cx="11970693" cy="1755973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A7058022-FC1B-BD46-9F08-535CC3B339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173065" y="3245088"/>
              <a:ext cx="2890126" cy="1755973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59EFEB3E-AE5F-174C-AD86-167129516D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4467" y="3245088"/>
              <a:ext cx="2890126" cy="1747697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1739E794-8D16-404F-8ADE-F751E2FCF6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235868" y="3245088"/>
              <a:ext cx="2890126" cy="1748063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8DFB18E2-59AB-0044-88DD-BFD5137000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5301" y="3245088"/>
              <a:ext cx="2876488" cy="1723421"/>
            </a:xfrm>
            <a:prstGeom prst="rect">
              <a:avLst/>
            </a:prstGeom>
          </p:spPr>
        </p:pic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82AC9E7B-779E-F047-BE49-D98270799674}"/>
              </a:ext>
            </a:extLst>
          </p:cNvPr>
          <p:cNvGrpSpPr/>
          <p:nvPr/>
        </p:nvGrpSpPr>
        <p:grpSpPr>
          <a:xfrm>
            <a:off x="124077" y="688003"/>
            <a:ext cx="11961297" cy="2164439"/>
            <a:chOff x="124077" y="971224"/>
            <a:chExt cx="11961297" cy="2164439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01C9395-8C44-874A-A79B-01CD59D833C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4077" y="971224"/>
              <a:ext cx="2890126" cy="2164439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942F7A17-870B-F74C-AFDD-757460E5AF3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47801" y="971224"/>
              <a:ext cx="2890126" cy="2164439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B5C7D217-62B8-9C4E-BE7E-0BFB1372AF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10800000">
              <a:off x="6171525" y="971224"/>
              <a:ext cx="2890126" cy="2164439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4D3F3144-2E38-4143-998B-71331C93C56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195248" y="971224"/>
              <a:ext cx="2890126" cy="2164439"/>
            </a:xfrm>
            <a:prstGeom prst="rect">
              <a:avLst/>
            </a:prstGeom>
          </p:spPr>
        </p:pic>
      </p:grpSp>
      <p:pic>
        <p:nvPicPr>
          <p:cNvPr id="53" name="Picture 52">
            <a:extLst>
              <a:ext uri="{FF2B5EF4-FFF2-40B4-BE49-F238E27FC236}">
                <a16:creationId xmlns:a16="http://schemas.microsoft.com/office/drawing/2014/main" id="{7BD9F435-8623-484E-81D4-07C311BD070E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81447" y="6955105"/>
            <a:ext cx="2890126" cy="2164439"/>
          </a:xfrm>
          <a:prstGeom prst="rect">
            <a:avLst/>
          </a:prstGeom>
        </p:spPr>
      </p:pic>
      <p:grpSp>
        <p:nvGrpSpPr>
          <p:cNvPr id="57" name="Group 56">
            <a:extLst>
              <a:ext uri="{FF2B5EF4-FFF2-40B4-BE49-F238E27FC236}">
                <a16:creationId xmlns:a16="http://schemas.microsoft.com/office/drawing/2014/main" id="{99420859-6F80-B246-AC6A-704C05814204}"/>
              </a:ext>
            </a:extLst>
          </p:cNvPr>
          <p:cNvGrpSpPr/>
          <p:nvPr/>
        </p:nvGrpSpPr>
        <p:grpSpPr>
          <a:xfrm>
            <a:off x="6345918" y="6281668"/>
            <a:ext cx="1244410" cy="369332"/>
            <a:chOff x="679731" y="3083944"/>
            <a:chExt cx="1244410" cy="369332"/>
          </a:xfrm>
        </p:grpSpPr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359B92F0-F30D-C54C-B108-F040EE9295A6}"/>
                </a:ext>
              </a:extLst>
            </p:cNvPr>
            <p:cNvCxnSpPr>
              <a:cxnSpLocks/>
            </p:cNvCxnSpPr>
            <p:nvPr/>
          </p:nvCxnSpPr>
          <p:spPr>
            <a:xfrm>
              <a:off x="679731" y="3429000"/>
              <a:ext cx="1244410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4BB0D54-2573-FA4C-ACC9-FEE75D827C13}"/>
                </a:ext>
              </a:extLst>
            </p:cNvPr>
            <p:cNvSpPr txBox="1"/>
            <p:nvPr/>
          </p:nvSpPr>
          <p:spPr>
            <a:xfrm>
              <a:off x="857755" y="3083944"/>
              <a:ext cx="9196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250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9465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2</Words>
  <Application>Microsoft Office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 Jones</dc:creator>
  <cp:lastModifiedBy>Kader Tanjina</cp:lastModifiedBy>
  <cp:revision>4</cp:revision>
  <dcterms:created xsi:type="dcterms:W3CDTF">2019-11-24T20:05:19Z</dcterms:created>
  <dcterms:modified xsi:type="dcterms:W3CDTF">2019-12-11T09:15:02Z</dcterms:modified>
</cp:coreProperties>
</file>